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705209-D21E-4D53-A6FF-7BF60D4E6A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2BA72F-F738-492F-821C-96B9ECFBCB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258733-5181-4200-80DF-647F01C73E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7FC8F8-088C-4F2E-98A8-2EE8A2294E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5CAD83-F22C-4777-A4A0-FEBCDD7115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33981F-EBA1-4EB7-89E9-37E39B2AE6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771668-22DF-4FF6-B27E-6069EF57A0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5FC062-66B7-4D6A-A02B-52A69199F5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FDA8C7-2DEF-4160-A3A3-9583F7E061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E03EA-82D1-4A77-B9C3-F30282F074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A8DBCB-31BF-4237-9461-8CC28F462C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633A06-4E8A-4F9A-B1EA-B20EA8F950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C878EC-D707-46E3-B7B8-79AFE5CBBCE7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C:\Users\user\Desktop\Microbiology Open\Supplementary data\Fig S3.tif"/>
          <p:cNvPicPr/>
          <p:nvPr/>
        </p:nvPicPr>
        <p:blipFill>
          <a:blip r:embed="rId1"/>
          <a:stretch/>
        </p:blipFill>
        <p:spPr>
          <a:xfrm>
            <a:off x="1357200" y="487440"/>
            <a:ext cx="5951520" cy="4370400"/>
          </a:xfrm>
          <a:prstGeom prst="rect">
            <a:avLst/>
          </a:prstGeom>
          <a:ln w="0">
            <a:noFill/>
          </a:ln>
        </p:spPr>
      </p:pic>
      <p:sp>
        <p:nvSpPr>
          <p:cNvPr id="42" name="TextBox 4"/>
          <p:cNvSpPr/>
          <p:nvPr/>
        </p:nvSpPr>
        <p:spPr>
          <a:xfrm>
            <a:off x="714240" y="5086440"/>
            <a:ext cx="8001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 S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Real time RT-PCR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alysis of select genes from microarray data that were found to be down-regulated in Δ</a:t>
            </a:r>
            <a:r>
              <a:rPr b="0" i="1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F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utant. Expression of genes was normalized with the </a:t>
            </a:r>
            <a:r>
              <a:rPr b="0" i="1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gA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ranscript level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e mean value and standard deviations were calculated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from two different experiments</a:t>
            </a:r>
            <a:r>
              <a:rPr b="0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plotted for each set of dat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08T06:42:50Z</dcterms:created>
  <dc:creator>user</dc:creator>
  <dc:description/>
  <dc:language>en-US</dc:language>
  <cp:lastModifiedBy>user</cp:lastModifiedBy>
  <dcterms:modified xsi:type="dcterms:W3CDTF">2015-08-08T06:55:10Z</dcterms:modified>
  <cp:revision>3</cp:revision>
  <dc:subject/>
  <dc:title>Slide 1</dc:title>
</cp:coreProperties>
</file>